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2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41" autoAdjust="0"/>
    <p:restoredTop sz="92462" autoAdjust="0"/>
  </p:normalViewPr>
  <p:slideViewPr>
    <p:cSldViewPr>
      <p:cViewPr>
        <p:scale>
          <a:sx n="100" d="100"/>
          <a:sy n="100" d="100"/>
        </p:scale>
        <p:origin x="-2808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7fs01.user.ki.se\Common$\Endokrinologi\Pathway%2027\LDH%20(cytotoxicity)\Summary%20LDH%20111-147%202014-2,9,11%2048%20h%20and%206%20day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sv-SE"/>
  <c:chart>
    <c:plotArea>
      <c:layout/>
      <c:barChart>
        <c:barDir val="col"/>
        <c:grouping val="clustered"/>
        <c:ser>
          <c:idx val="0"/>
          <c:order val="0"/>
          <c:tx>
            <c:strRef>
              <c:f>'[Summary LDH 111-147 2014-2,9,11 48 h and 6 days.xlsx]Blad1'!$A$48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'[Summary LDH 111-147 2014-2,9,11 48 h and 6 days.xlsx]Blad1'!$B$110:$G$110</c:f>
                <c:numCache>
                  <c:formatCode>General</c:formatCode>
                  <c:ptCount val="6"/>
                  <c:pt idx="0">
                    <c:v>0.22407342308659195</c:v>
                  </c:pt>
                  <c:pt idx="1">
                    <c:v>0.25148843172489144</c:v>
                  </c:pt>
                  <c:pt idx="2">
                    <c:v>0.19699149178396266</c:v>
                  </c:pt>
                  <c:pt idx="3">
                    <c:v>0.16987835453872618</c:v>
                  </c:pt>
                  <c:pt idx="4">
                    <c:v>0.38658614327416513</c:v>
                  </c:pt>
                  <c:pt idx="5">
                    <c:v>0.140541063267663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[Summary LDH 111-147 2014-2,9,11 48 h and 6 days.xlsx]Blad1'!$B$112:$G$113</c:f>
              <c:multiLvlStrCache>
                <c:ptCount val="6"/>
                <c:lvl>
                  <c:pt idx="0">
                    <c:v>Control</c:v>
                  </c:pt>
                  <c:pt idx="1">
                    <c:v>DHA</c:v>
                  </c:pt>
                  <c:pt idx="2">
                    <c:v>AC</c:v>
                  </c:pt>
                  <c:pt idx="3">
                    <c:v>PI</c:v>
                  </c:pt>
                  <c:pt idx="4">
                    <c:v>DHA </c:v>
                  </c:pt>
                  <c:pt idx="5">
                    <c:v>DHA </c:v>
                  </c:pt>
                </c:lvl>
                <c:lvl>
                  <c:pt idx="4">
                    <c:v>AC</c:v>
                  </c:pt>
                  <c:pt idx="5">
                    <c:v>PI</c:v>
                  </c:pt>
                </c:lvl>
              </c:multiLvlStrCache>
            </c:multiLvlStrRef>
          </c:cat>
          <c:val>
            <c:numRef>
              <c:f>'[Summary LDH 111-147 2014-2,9,11 48 h and 6 days.xlsx]Blad1'!$B$109:$G$109</c:f>
              <c:numCache>
                <c:formatCode>General</c:formatCode>
                <c:ptCount val="6"/>
                <c:pt idx="0">
                  <c:v>1.0079693912956158</c:v>
                </c:pt>
                <c:pt idx="1">
                  <c:v>0.72610717075327003</c:v>
                </c:pt>
                <c:pt idx="2">
                  <c:v>0.67448518949581859</c:v>
                </c:pt>
                <c:pt idx="3">
                  <c:v>0.54215110232382835</c:v>
                </c:pt>
                <c:pt idx="4">
                  <c:v>0.84928440239572289</c:v>
                </c:pt>
                <c:pt idx="5">
                  <c:v>0.70444688410527179</c:v>
                </c:pt>
              </c:numCache>
            </c:numRef>
          </c:val>
        </c:ser>
        <c:ser>
          <c:idx val="1"/>
          <c:order val="1"/>
          <c:tx>
            <c:strRef>
              <c:f>'[Summary LDH 111-147 2014-2,9,11 48 h and 6 days.xlsx]Blad1'!$A$58</c:f>
              <c:strCache>
                <c:ptCount val="1"/>
                <c:pt idx="0">
                  <c:v>6 day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'[Summary LDH 111-147 2014-2,9,11 48 h and 6 days.xlsx]Blad1'!$B$115:$G$115</c:f>
                <c:numCache>
                  <c:formatCode>General</c:formatCode>
                  <c:ptCount val="6"/>
                  <c:pt idx="0">
                    <c:v>7.3147567380358547E-2</c:v>
                  </c:pt>
                  <c:pt idx="1">
                    <c:v>0.23327291049078386</c:v>
                  </c:pt>
                  <c:pt idx="2">
                    <c:v>0.18287800000000001</c:v>
                  </c:pt>
                  <c:pt idx="3">
                    <c:v>0.19984063172026117</c:v>
                  </c:pt>
                  <c:pt idx="4">
                    <c:v>0.12741900000000006</c:v>
                  </c:pt>
                  <c:pt idx="5">
                    <c:v>0.212108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[Summary LDH 111-147 2014-2,9,11 48 h and 6 days.xlsx]Blad1'!$B$112:$G$113</c:f>
              <c:multiLvlStrCache>
                <c:ptCount val="6"/>
                <c:lvl>
                  <c:pt idx="0">
                    <c:v>Control</c:v>
                  </c:pt>
                  <c:pt idx="1">
                    <c:v>DHA</c:v>
                  </c:pt>
                  <c:pt idx="2">
                    <c:v>AC</c:v>
                  </c:pt>
                  <c:pt idx="3">
                    <c:v>PI</c:v>
                  </c:pt>
                  <c:pt idx="4">
                    <c:v>DHA </c:v>
                  </c:pt>
                  <c:pt idx="5">
                    <c:v>DHA </c:v>
                  </c:pt>
                </c:lvl>
                <c:lvl>
                  <c:pt idx="4">
                    <c:v>AC</c:v>
                  </c:pt>
                  <c:pt idx="5">
                    <c:v>PI</c:v>
                  </c:pt>
                </c:lvl>
              </c:multiLvlStrCache>
            </c:multiLvlStrRef>
          </c:cat>
          <c:val>
            <c:numRef>
              <c:f>'[Summary LDH 111-147 2014-2,9,11 48 h and 6 days.xlsx]Blad1'!$B$114:$G$114</c:f>
              <c:numCache>
                <c:formatCode>General</c:formatCode>
                <c:ptCount val="6"/>
                <c:pt idx="0">
                  <c:v>1</c:v>
                </c:pt>
                <c:pt idx="1">
                  <c:v>0.93283333905703258</c:v>
                </c:pt>
                <c:pt idx="2">
                  <c:v>0.76993599999999995</c:v>
                </c:pt>
                <c:pt idx="3">
                  <c:v>0.8396203798380526</c:v>
                </c:pt>
                <c:pt idx="4">
                  <c:v>0.76223300000000005</c:v>
                </c:pt>
                <c:pt idx="5">
                  <c:v>0.94794199999999995</c:v>
                </c:pt>
              </c:numCache>
            </c:numRef>
          </c:val>
        </c:ser>
        <c:gapWidth val="50"/>
        <c:axId val="47604096"/>
        <c:axId val="47606784"/>
      </c:barChart>
      <c:catAx>
        <c:axId val="47604096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47606784"/>
        <c:crosses val="autoZero"/>
        <c:auto val="1"/>
        <c:lblAlgn val="ctr"/>
        <c:lblOffset val="100"/>
        <c:noMultiLvlLbl val="1"/>
      </c:catAx>
      <c:valAx>
        <c:axId val="4760678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800"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800" b="1">
                    <a:latin typeface="Arial" panose="020B0604020202020204" pitchFamily="34" charset="0"/>
                    <a:cs typeface="Arial" panose="020B0604020202020204" pitchFamily="34" charset="0"/>
                  </a:rPr>
                  <a:t>Relative LDH activity</a:t>
                </a:r>
              </a:p>
            </c:rich>
          </c:tx>
          <c:layout>
            <c:manualLayout>
              <c:xMode val="edge"/>
              <c:yMode val="edge"/>
              <c:x val="2.9052287581699365E-2"/>
              <c:y val="0.20309523809523822"/>
            </c:manualLayout>
          </c:layout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476040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1823823529411788"/>
          <c:y val="5.6236111111111139E-3"/>
          <c:w val="0.17761143790849679"/>
          <c:h val="0.17148425925925925"/>
        </c:manualLayout>
      </c:layout>
      <c:overlay val="1"/>
      <c:txPr>
        <a:bodyPr/>
        <a:lstStyle/>
        <a:p>
          <a:pPr>
            <a:defRPr sz="8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sv-SE"/>
        </a:p>
      </c:txPr>
    </c:legend>
    <c:plotVisOnly val="1"/>
    <c:dispBlanksAs val="gap"/>
  </c:chart>
  <c:spPr>
    <a:ln>
      <a:noFill/>
    </a:ln>
  </c:sp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9838F09E-6F71-4903-8F79-974843AD4203}" type="datetimeFigureOut">
              <a:rPr lang="en-GB"/>
              <a:pPr>
                <a:defRPr/>
              </a:pPr>
              <a:t>11/01/2016</a:t>
            </a:fld>
            <a:endParaRPr lang="en-GB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373E8D55-4FBB-4C93-BB28-EEFC699AA60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2545655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F924E2A2-3A3D-487C-924F-5926C3A54E64}" type="datetimeFigureOut">
              <a:rPr lang="en-GB"/>
              <a:pPr>
                <a:defRPr/>
              </a:pPr>
              <a:t>11/01/2016</a:t>
            </a:fld>
            <a:endParaRPr lang="en-GB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noProof="0" smtClean="0"/>
              <a:t>Klicka här för att ändra format på bakgrundstexten</a:t>
            </a:r>
          </a:p>
          <a:p>
            <a:pPr lvl="1"/>
            <a:r>
              <a:rPr lang="sv-SE" noProof="0" smtClean="0"/>
              <a:t>Nivå två</a:t>
            </a:r>
          </a:p>
          <a:p>
            <a:pPr lvl="2"/>
            <a:r>
              <a:rPr lang="sv-SE" noProof="0" smtClean="0"/>
              <a:t>Nivå tre</a:t>
            </a:r>
          </a:p>
          <a:p>
            <a:pPr lvl="3"/>
            <a:r>
              <a:rPr lang="sv-SE" noProof="0" smtClean="0"/>
              <a:t>Nivå fyra</a:t>
            </a:r>
          </a:p>
          <a:p>
            <a:pPr lvl="4"/>
            <a:r>
              <a:rPr lang="sv-SE" noProof="0" smtClean="0"/>
              <a:t>Nivå fem</a:t>
            </a:r>
            <a:endParaRPr lang="en-GB" noProof="0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1B0FD712-E056-479C-B687-5F50158B247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8291070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Platshållare för bildobjekt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3315" name="Platshållare för anteckninga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GB" altLang="en-US" smtClean="0"/>
              <a:t>Low DHA+AC ej sign pga outlier</a:t>
            </a:r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2851529A-131D-4E7D-AF26-08A9D0A73A28}" type="slidenum">
              <a:rPr lang="en-GB" smtClean="0"/>
              <a:pPr>
                <a:defRPr/>
              </a:pPr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FFB47D-6699-4374-B20D-C32FB3EF1FDB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EEE77B-A8E1-49D1-939F-4BFC4F7945D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2847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8A201B-59DA-49A6-83C7-B79321A0A7AB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7AE2C4-533A-48C1-98D8-58B57E36F1E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43146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2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FBC042-70B2-45AE-BD06-2090D6D12D89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336CED-9BAD-432A-BD2E-586EE0CA53A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60036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649EB2-F9BC-40E8-B276-092DEDC6901F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2B1DE4-FCEA-4EE4-84AB-B0FC6C95FA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81462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1E70FB-17F2-4FB0-A09D-06FF41E71A35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3E5D26-50B0-4CD5-AC15-C55387FFE5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560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4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B5825B-AC0F-41EA-A5B9-32C2C2007AFA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C832C1-E6C5-4714-A79D-BD20FC30914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3457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9DE8A0-91FB-431A-AD5C-755469074929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6DC068-22E1-4722-BCA3-4B105DD37A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73889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70BAF2-ECF2-4206-AD98-C23CCE289029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331FDF-C831-40B0-B98C-B0C2A57FB4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89790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85776E-E103-4493-9EA1-6BBA2E278F1C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093AB8-6EB4-496B-A98E-27ACE4921D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45538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9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FAB479-DCC5-46DE-8F65-0D6DC944DD1D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5ADF7C-8E6E-4512-954A-E4C96F246C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47410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85C18-9133-4843-834B-51F497B1A0C6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BB35AF-2503-4977-ADF9-8C448A7917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09456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2B3C14E-EDD2-41C0-9DA1-06EB77B58C57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F2549D4-A688-4D6C-8179-872F6D0913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Diagram 5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26927697"/>
              </p:ext>
            </p:extLst>
          </p:nvPr>
        </p:nvGraphicFramePr>
        <p:xfrm>
          <a:off x="324000" y="476545"/>
          <a:ext cx="30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195" name="textruta 8"/>
          <p:cNvSpPr txBox="1">
            <a:spLocks noChangeArrowheads="1"/>
          </p:cNvSpPr>
          <p:nvPr/>
        </p:nvSpPr>
        <p:spPr bwMode="auto">
          <a:xfrm>
            <a:off x="2016000" y="1241630"/>
            <a:ext cx="5365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charset="0"/>
              </a:rPr>
              <a:t>***</a:t>
            </a:r>
          </a:p>
        </p:txBody>
      </p:sp>
      <p:sp>
        <p:nvSpPr>
          <p:cNvPr id="8197" name="textruta 10"/>
          <p:cNvSpPr txBox="1">
            <a:spLocks noChangeArrowheads="1"/>
          </p:cNvSpPr>
          <p:nvPr/>
        </p:nvSpPr>
        <p:spPr bwMode="auto">
          <a:xfrm>
            <a:off x="2949154" y="1108135"/>
            <a:ext cx="5365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***</a:t>
            </a:r>
          </a:p>
        </p:txBody>
      </p:sp>
      <p:sp>
        <p:nvSpPr>
          <p:cNvPr id="8199" name="textruta 3"/>
          <p:cNvSpPr txBox="1">
            <a:spLocks noChangeArrowheads="1"/>
          </p:cNvSpPr>
          <p:nvPr/>
        </p:nvSpPr>
        <p:spPr bwMode="auto">
          <a:xfrm>
            <a:off x="1227240" y="966437"/>
            <a:ext cx="5365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charset="0"/>
              </a:rPr>
              <a:t>***</a:t>
            </a:r>
          </a:p>
        </p:txBody>
      </p:sp>
      <p:sp>
        <p:nvSpPr>
          <p:cNvPr id="8200" name="textruta 7"/>
          <p:cNvSpPr txBox="1">
            <a:spLocks noChangeArrowheads="1"/>
          </p:cNvSpPr>
          <p:nvPr/>
        </p:nvSpPr>
        <p:spPr bwMode="auto">
          <a:xfrm>
            <a:off x="1620000" y="1056447"/>
            <a:ext cx="39638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charset="0"/>
              </a:rPr>
              <a:t>***</a:t>
            </a:r>
          </a:p>
        </p:txBody>
      </p:sp>
      <p:sp>
        <p:nvSpPr>
          <p:cNvPr id="10" name="textruta 8"/>
          <p:cNvSpPr txBox="1">
            <a:spLocks noChangeArrowheads="1"/>
          </p:cNvSpPr>
          <p:nvPr/>
        </p:nvSpPr>
        <p:spPr bwMode="auto">
          <a:xfrm>
            <a:off x="2798930" y="1106615"/>
            <a:ext cx="5365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charset="0"/>
              </a:rPr>
              <a:t>***</a:t>
            </a:r>
          </a:p>
        </p:txBody>
      </p:sp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413665" y="2726795"/>
            <a:ext cx="6300700" cy="1631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Additional file </a:t>
            </a:r>
            <a:r>
              <a:rPr lang="en-US" sz="10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: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S3.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Decreased cytotoxicity after treatment with bioactive compounds or metabolites.</a:t>
            </a:r>
            <a:endParaRPr kumimoji="0" lang="sv-SE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Lactate dehydrogenase (LDH) activity after 48 hours or 6 days treatment with bioactive compounds relative to control in conditioned media. Forty-eight hours; control, n=9; 0.5 µM DHA, n=6; AC alone and with DHA, n=3; 100 µM PI alone and with DHA, n=4 biological/independent experiments in quadruplicates; 6 days; control, n=7; 0.5 µM DHA, n=7; AC alone and with DHA, n=4; 100 µM PI alone and with DHA, n=5 biological/independent experiments in duplicates. Normalized data is adjusted for protein amount in each well as a measure of cell amount and presented as means +/- standard deviation. *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p&lt;0.05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, **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p&lt;0.01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and ***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p&lt;0.001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versus control. Statistical significance was determined by one-way ANOVA with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Tukey’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multiple comparisons post hoc test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>
          <a:noFill/>
        </a:ln>
        <a:extLst>
          <a:ext uri="{909E8E84-426E-40DD-AFC4-6F175D3DCCD1}">
            <a14:hiddenFill xmlns=""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=""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>
        <a:spAutoFit/>
      </a:bodyPr>
      <a:lstStyle>
        <a:defPPr eaLnBrk="1" hangingPunct="1">
          <a:spcBef>
            <a:spcPct val="0"/>
          </a:spcBef>
          <a:buFontTx/>
          <a:buNone/>
          <a:defRPr sz="900" dirty="0" smtClean="0">
            <a:latin typeface="Arial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43</TotalTime>
  <Words>175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indows Us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nie</dc:creator>
  <cp:lastModifiedBy>CM</cp:lastModifiedBy>
  <cp:revision>442</cp:revision>
  <cp:lastPrinted>2014-10-27T13:04:57Z</cp:lastPrinted>
  <dcterms:created xsi:type="dcterms:W3CDTF">2014-02-13T13:47:19Z</dcterms:created>
  <dcterms:modified xsi:type="dcterms:W3CDTF">2016-01-11T13:12:53Z</dcterms:modified>
</cp:coreProperties>
</file>